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4" r:id="rId4"/>
    <p:sldId id="265" r:id="rId5"/>
    <p:sldId id="266" r:id="rId6"/>
    <p:sldId id="267" r:id="rId7"/>
    <p:sldId id="268" r:id="rId8"/>
    <p:sldId id="269" r:id="rId9"/>
    <p:sldId id="270" r:id="rId10"/>
    <p:sldId id="271" r:id="rId11"/>
    <p:sldId id="272" r:id="rId12"/>
    <p:sldId id="273" r:id="rId13"/>
    <p:sldId id="274" r:id="rId14"/>
    <p:sldId id="275" r:id="rId15"/>
    <p:sldId id="276" r:id="rId16"/>
    <p:sldId id="257" r:id="rId17"/>
    <p:sldId id="258" r:id="rId18"/>
    <p:sldId id="259" r:id="rId19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0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1811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068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798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8162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7450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1713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459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0960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5449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4634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257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6BE698-5214-490B-AACB-DA231AF132F1}" type="datetimeFigureOut">
              <a:rPr lang="zh-CN" altLang="en-US" smtClean="0"/>
              <a:t>2017-3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F46A3-4D25-43A4-9715-839647A3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4672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Picture 1" descr="C:\Users\dell\AppData\Roaming\Tencent\Users\546824183\QQ\WinTemp\RichOle\5VOR1Z_5{IXR7`PI1_4Q12Q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753600" cy="6505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19387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1" name="Picture 1" descr="C:\Users\dell\AppData\Roaming\Tencent\Users\546824183\QQ\WinTemp\RichOle\TQRUZ(2HWTT929ZEW[Y$ISB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458325" cy="6400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8722712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5" name="Picture 1" descr="C:\Users\dell\AppData\Roaming\Tencent\Users\546824183\QQ\WinTemp\RichOle\MWW)Y9}7V8UDBBJ691FO8VA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458325" cy="63531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9632304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AutoShape 1" descr="C:\Users\dell\AppData\Roaming\Tencent\Users\546824183\QQ\WinTemp\RichOle\415Ff8U2IVHX)D04]TL_S.png"/>
          <p:cNvSpPr>
            <a:spLocks noChangeAspect="1" noChangeArrowheads="1"/>
          </p:cNvSpPr>
          <p:nvPr/>
        </p:nvSpPr>
        <p:spPr bwMode="auto">
          <a:xfrm>
            <a:off x="0" y="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" name="AutoShape 2" descr="C:\Users\dell\AppData\Roaming\Tencent\Users\546824183\QQ\WinTemp\RichOle\415Ff8U2IVHX)D04]TL_S.png"/>
          <p:cNvSpPr>
            <a:spLocks noChangeAspect="1" noChangeArrowheads="1"/>
          </p:cNvSpPr>
          <p:nvPr/>
        </p:nvSpPr>
        <p:spPr bwMode="auto">
          <a:xfrm>
            <a:off x="152400" y="1524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3363"/>
            <a:ext cx="9286875" cy="6391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01304987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3" name="Picture 1" descr="C:\Users\dell\AppData\Roaming\Tencent\Users\546824183\QQ\WinTemp\RichOle\7%ET8KVTSEN[7(L`1YC)@JI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515475" cy="6334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337028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7" name="Picture 1" descr="C:\Users\dell\AppData\Roaming\Tencent\Users\546824183\QQ\WinTemp\RichOle\~X4NYL]%~ZNHHKTU(8(G935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334500" cy="6334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1124400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1" name="Picture 1" descr="C:\Users\dell\AppData\Roaming\Tencent\Users\546824183\QQ\WinTemp\RichOle\7DXD36H~0[2FF%9P4~S)A)Q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705975" cy="6305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6348671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Picture 1" descr="C:\Users\dell\AppData\Roaming\Tencent\Users\546824183\QQ\WinTemp\RichOle\_M_GLZG8Q[]JM)2DT[49U7A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544050" cy="6477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8517235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 descr="C:\Users\dell\AppData\Roaming\Tencent\Users\546824183\QQ\WinTemp\RichOle\UYI(%J]WRMUAQ)FR)U0%VD3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620250" cy="6457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5428598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3" name="Picture 1" descr="C:\Users\dell\AppData\Roaming\Tencent\Users\546824183\QQ\WinTemp\RichOle\{39[~@R76$U0UJK0(}1326L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572625" cy="63817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84459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 descr="C:\Users\dell\AppData\Roaming\Tencent\Users\546824183\QQ\WinTemp\RichOle\$FN1QYPPHD[_O9~O_YZW6EW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791700" cy="6534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993619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3" name="Picture 1" descr="C:\Users\dell\AppData\Roaming\Tencent\Users\546824183\QQ\WinTemp\RichOle\WRVW$$@R3{48KH6BK`4TWPH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344025" cy="6486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058007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Picture 1" descr="C:\Users\dell\AppData\Roaming\Tencent\Users\546824183\QQ\WinTemp\RichOle\UCKDA2}L6GZ)(S(SG2O3A6C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725025" cy="6524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720306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1" name="Picture 1" descr="C:\Users\dell\AppData\Roaming\Tencent\Users\546824183\QQ\WinTemp\RichOle\S_0PHFY%SSI(YEP_8@O}P$P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934575" cy="6486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308849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 descr="C:\Users\dell\AppData\Roaming\Tencent\Users\546824183\QQ\WinTemp\RichOle\XMOK1D4%O`WQ(UZJMLUX{0T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753600" cy="6600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971049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69" name="Picture 1" descr="C:\Users\dell\AppData\Roaming\Tencent\Users\546824183\QQ\WinTemp\RichOle\TY][@LJOBAL2IIH@RV4HZCI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658350" cy="6438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451843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3" name="Picture 1" descr="C:\Users\dell\AppData\Roaming\Tencent\Users\546824183\QQ\WinTemp\RichOle\$2OK@K4AJV{]~V08]`G{QIC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410700" cy="6286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818258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7" name="Picture 1" descr="C:\Users\dell\AppData\Roaming\Tencent\Users\546824183\QQ\WinTemp\RichOle\Z[@R2AWFJ(M_8O920$V7H06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696450" cy="6400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03459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0</Words>
  <Application>Microsoft Office PowerPoint</Application>
  <PresentationFormat>全屏显示(4:3)</PresentationFormat>
  <Paragraphs>0</Paragraphs>
  <Slides>18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19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dell</cp:lastModifiedBy>
  <cp:revision>5</cp:revision>
  <dcterms:created xsi:type="dcterms:W3CDTF">2017-03-20T09:44:28Z</dcterms:created>
  <dcterms:modified xsi:type="dcterms:W3CDTF">2017-03-23T03:46:15Z</dcterms:modified>
</cp:coreProperties>
</file>